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5F1FB-2DC5-4A1F-8262-658182B79A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F1A9E-2BC8-426B-91C7-76525889B4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747F5-7FFC-4C65-AAB6-E705C8368B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B5AA53-40A8-49C4-AE2A-21BBAB4C15D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B7A01-4305-44F1-9A95-B624141C4E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94F85-77A5-4CCF-98D6-BB99F396EF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33FD3F-5EA9-4DB8-B327-03187AF09EA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3FFD0-1094-483B-AFD3-2FFD86E47F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1B59AC-436C-4AEF-BD09-D9FC10D088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2FB82-0124-46FD-9AA2-B86227EF97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6093A-2C08-4E4D-900C-5CD6B7AEE6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EA9310-1384-4379-B356-86F79FA761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033F76-85D5-4C3B-806C-F028C8EC6E86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179280" y="18900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iological Proc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5" descr="L1vsAll_biological_process"/>
          <p:cNvPicPr/>
          <p:nvPr/>
        </p:nvPicPr>
        <p:blipFill>
          <a:blip r:embed="rId1"/>
          <a:stretch/>
        </p:blipFill>
        <p:spPr>
          <a:xfrm>
            <a:off x="287280" y="2276640"/>
            <a:ext cx="8569440" cy="1598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 Box 4"/>
          <p:cNvSpPr/>
          <p:nvPr/>
        </p:nvSpPr>
        <p:spPr>
          <a:xfrm>
            <a:off x="179280" y="18900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lecular Funct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6" descr="L1vsAll_molecular_function"/>
          <p:cNvPicPr/>
          <p:nvPr/>
        </p:nvPicPr>
        <p:blipFill>
          <a:blip r:embed="rId1"/>
          <a:stretch/>
        </p:blipFill>
        <p:spPr>
          <a:xfrm>
            <a:off x="250920" y="2927520"/>
            <a:ext cx="8719920" cy="1114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5" descr="L1vsAll_cellular_component"/>
          <p:cNvPicPr/>
          <p:nvPr/>
        </p:nvPicPr>
        <p:blipFill>
          <a:blip r:embed="rId1"/>
          <a:stretch/>
        </p:blipFill>
        <p:spPr>
          <a:xfrm>
            <a:off x="1673280" y="326880"/>
            <a:ext cx="5405400" cy="6342120"/>
          </a:xfrm>
          <a:prstGeom prst="rect">
            <a:avLst/>
          </a:prstGeom>
          <a:ln w="0">
            <a:noFill/>
          </a:ln>
        </p:spPr>
      </p:pic>
      <p:sp>
        <p:nvSpPr>
          <p:cNvPr id="46" name="Text Box 4"/>
          <p:cNvSpPr/>
          <p:nvPr/>
        </p:nvSpPr>
        <p:spPr>
          <a:xfrm>
            <a:off x="179280" y="260280"/>
            <a:ext cx="4176720" cy="6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ellular Componen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 vs. root transcriptome databas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23T15:59:03Z</dcterms:created>
  <dc:creator>Customer</dc:creator>
  <dc:description/>
  <dc:language>en-US</dc:language>
  <cp:lastModifiedBy>vcfiron</cp:lastModifiedBy>
  <dcterms:modified xsi:type="dcterms:W3CDTF">2013-04-25T13:50:46Z</dcterms:modified>
  <cp:revision>6</cp:revision>
  <dc:subject/>
  <dc:title>Slide 1</dc:title>
</cp:coreProperties>
</file>